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2"/>
    <p:restoredTop sz="94674"/>
  </p:normalViewPr>
  <p:slideViewPr>
    <p:cSldViewPr snapToGrid="0" showGuides="1">
      <p:cViewPr>
        <p:scale>
          <a:sx n="253" d="100"/>
          <a:sy n="253" d="100"/>
        </p:scale>
        <p:origin x="-824" y="-832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031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1624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6929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43415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25387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93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7149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046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718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8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2376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9EDFDD-41E3-4E68-ADE9-A03CA4A99969}" type="datetimeFigureOut">
              <a:rPr lang="en-US" smtClean="0"/>
              <a:t>11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8A46DC-EDFA-43EC-B982-778F67656E9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6958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841C2F2F-2980-FD47-818A-474B1CF85C27}"/>
              </a:ext>
            </a:extLst>
          </p:cNvPr>
          <p:cNvSpPr txBox="1"/>
          <p:nvPr/>
        </p:nvSpPr>
        <p:spPr>
          <a:xfrm>
            <a:off x="224133" y="595671"/>
            <a:ext cx="372466" cy="379876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3" name="Rectangle 2"/>
          <p:cNvSpPr/>
          <p:nvPr/>
        </p:nvSpPr>
        <p:spPr>
          <a:xfrm>
            <a:off x="22528" y="1173481"/>
            <a:ext cx="7772400" cy="6873961"/>
          </a:xfrm>
          <a:prstGeom prst="rect">
            <a:avLst/>
          </a:prstGeom>
        </p:spPr>
        <p:txBody>
          <a:bodyPr wrap="square" lIns="101882" tIns="50941" rIns="101882" bIns="50941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TTTCAGCTTTTTCTGAAATGTTTGGCTCCGATTACGAGCCTCAAGGCGGAGATTATTGTCCGACGT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TTTCAGCTTTTTCTGAAATGTTTGGCTCCGATTACGAGCCTCAAGGCGGAGATTATTGTCCGACGT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TTTCAGCTTTTTCTGAAATGTTTGGCTCCGATTACGAGCCTCAAGGCGGAGATTATTGTCCGACGT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TTTCAGCTTTTTCTGAAATGTTTGGCTCCGATTACGAGCCTCAAGGCGGAGATTATTGTCCGACGT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CGAGTTGTCCGAAGAAACCGGCGGG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AAGAAGTTTCG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TCGTCACCCAATTTACAGAGGAGTTCGTCA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CGAGTTGTCCGAAGAAACCGGCGGG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AAGAAGTTTCG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TCGTCACCCAATTTACAGAGGAGTTCGTCA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CGAGTTGTCCGAAGAAACCGGCGGG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AAGAAGTTTCG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TCGTCACCCAATTTACAGAGGAGTTCGTCA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CGAGTTGTCCGAAGAAACCGGCGGG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AAGAAGTTTCG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TCGTCACCCAATTTACAGAGGAGTTCGTCA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ACTCCGGTAAGTGGG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GTGAGAGAGCCAAACAAGAAAA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GGATTTGGCTCGGGACTTTCCAAACCG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ACTCCGGTAAGTGGG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GTGAGAGAGCCAAACAAGAAAA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GGATTTGGCTCGGGACTTTCCAAACCG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ACTCCGGTAAGTGGG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GTGAGAGAGCCAAACAAGAAAA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GGATTTGGCTCGGGACTTTCCAAACCG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ACTCCGGTAAGTGGG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GTGAGAGAGCCAAACAAGAAAA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GGATTTGGCTCGGGACTTTCCAAACCG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ATGGCAGCTCGTGCTCACGACGTCGCTGCATTAGC</a:t>
            </a:r>
            <a:r>
              <a:rPr lang="en-US" sz="1000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CTCCGTGGCCGATCAGC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TCTCAACTTCGCTGACTC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ATGGCAGCTCGTGCTCACGACGTCGCTGCATTAGC</a:t>
            </a:r>
            <a:r>
              <a:rPr lang="en-US" sz="10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------------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TCTCAACTTCGCTGACTC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0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ATGGCAGCTCGTGCTCACGACGTCGCTGCAT</a:t>
            </a:r>
            <a:r>
              <a:rPr lang="en-US" sz="1000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AGCCC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CGTGGCCGATCAGCATGTCTCAACTTCGCTGACTC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ATGGCAGCTCGTGCTCACGACGTCGCTGCATT</a:t>
            </a:r>
            <a:r>
              <a:rPr lang="en-US" sz="10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CGTGGCCGATCAGCATGTCTCAACTTCGCTGACTC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1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GGCGGCTACGAATCC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TCAACATGCGCCAAGGATATCCAAAAAGCGGCTGCTGAAGCGGCGTTGGCTTTTCA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0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GGCGGCTACGAATCC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TCAACATGCGCCAAGGATATCCAAAAAGCGGCTGCTGAAGCGGCGTTGGCTTTTCA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8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GGCGGCTACGAATCC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TCAACATGCGCCAAGGATATCCAAAAAGCGGCTGCTGAAGCGGCGTTGGCTTTTCA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0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GGCGGCTACGAATCC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GTCAACATGCGCCAAGGATATCCAAAAAGCGGCTGCTGAAGCGGCGTTGGCTTTTCA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9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GACGTGTGATACGACGACCACGGATCATGGCCTGGACATGGAGGAGACGATGGTGGAAGCTATTTATACACCGG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8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GACGTGTGATACGACGACCACGGATCATGGCCTGGACATGGAGGAGACGATGGTGGAAGCTATTTATACACCGG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6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GACGTGTGATACGACGACCACGGATCATGGCCTGGACATGGAGGAGACGATGGTGGAAGCTATTTATACACCGG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8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GACGTGTGATACGACGACCACGGATCATGGCCTGGACATGGAGGAGACGATGGTGGAAGCTATTTATACACCGG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7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GAGCGAAGGTGCGTTTTATATGGATGAGGAGACAATGTTTGGGATGCC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TGTTGGATAATATGGCTGAAGGC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GAGCGAAGGTGCGTTTTATATGGATGAGGAGACAATGTTTGGGATGCC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TGTTGGATAATATGGCTGAAGGC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4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GAGCGAAGGTGCGTTTTATATGGATGAGGAGACAATGTTTGGGATGCC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TGTTGGATAATATGGCTGAAGGC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GAGCGAAGGTGCGTTTTATATGGATGAGGAGACAATGTTTGGGATGCC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TGTTGGATAATATGGCTGAAGGC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5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TTTTACCGCCGCCGTCTGTTC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ATCATAATTATGACGGCGAAGGAGATGGTGACGTGTCGCTTTGGAGTTA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TTTTACCGCCGCCGTCTGTTC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ATCATAATTATGACGGCGAAGGAGATGGTGACGTGTCGCTTTGGAGTTA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2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TTTTACCGCCGCCGTCTGTTC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ATCATAATTATGACGGCGAAGGAGATGGTGACGTGTCGCTTTGGAGTTA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TTTTACCGCCGCCGTCTGTTC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ATCATAATTATGACGGCGAAGGAGATGGTGACGTGTCGCTTTGGAGTTAC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24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76981" y="132735"/>
            <a:ext cx="929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</a:p>
        </p:txBody>
      </p:sp>
    </p:spTree>
    <p:extLst>
      <p:ext uri="{BB962C8B-B14F-4D97-AF65-F5344CB8AC3E}">
        <p14:creationId xmlns:p14="http://schemas.microsoft.com/office/powerpoint/2010/main" val="2985084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8186" y="950773"/>
            <a:ext cx="7755128" cy="8412844"/>
          </a:xfrm>
          <a:prstGeom prst="rect">
            <a:avLst/>
          </a:prstGeom>
        </p:spPr>
        <p:txBody>
          <a:bodyPr wrap="square" lIns="101882" tIns="50941" rIns="101882" bIns="50941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TGCTTTTTCTGAAATGTTTGGCTCCGATTACGAGTCTCCGGTTTCCTCAGGCGGTGATTACAG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TGCTTTTTCTGAAATGTTTGGCTCCGATTACGAGTCTCCGGTTTCCTCAGGCGGTGATTACAG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TGCTTTTTCTGAAATGTTTGGCTCCGATTACGAGTCTCCGGTTTCCTCAGGCGGTGATTACAG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TGCTTTTTCTGAAATGTTTGGCTCCGATTACGAGTCTCCGGTTTCCTCAGGCGGTGATTACAG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ACTCA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TGCTTTTTCTGAAATGTTTGGCTCCGATTACGAGTCTCCGGTTTCCTCAGGCGGTGATTACAG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GCTTGCCACGAGCTGCCCCAAGAAACCAGCGGGAAGGAAGAAGTTTCGTGAGACTCGTCACCCAATT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GCTTGCCACGAGCTGCCCCAAGAAACCAGCGGGAAGGAAGAAGTTTCGTGAGACTCGTCACCCAATT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GCTTGCCACGAGCTGCCCCAAGAAACCAGCGGGAAGGAAGAAGTTTCGTGAGACTCGTCACCCAATT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GCTTGCCACGAGCTGCCCCAAGAAACCAGCGGGAAGGAAGAAGTTTCGTGAGACTCGTCACCCAATT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AGCTTGCCACGAGCTGCCCCAAGAAACCAGCGGGAAGGAAGAAGTTTCGTGAGACTCGTCACCCAATT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AAAGAAACTCCGGTAAGTGGGTGTGTGAGTTGAGAGAGCCAAACAAGAAAACGAGGATTTGGCTCGGGACTTT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AAAGAAACTCCGGTAAGTGGGTGTGTGAGTTGAGAGAGCCAAACAAGAAAACGAGGATTTGGCTCGGGACTTT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AAAGAAACTCCGGTAAGTGGGTGTGTGAGTTGAGAGAGCCAAACAAGAAAACGAGGATTTGGCTCGGGACTTT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AAAGAAACTCCGGTAAGTGGGTGTGTGAGTTGAGAGAGCCAAACAAGAAAACGAGGATTTGGCTCGGGACTTT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AAAGAAACTCCGGTAAGTGGGTGTGTGAGTTGAGAGAGCCAAACAAGAAAACGAGGATTTGGCTCGGGACTTT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TGCTCACGACGTCGCCGCCATAGCT</a:t>
            </a:r>
            <a:r>
              <a:rPr lang="en-US" sz="1000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TCCGT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AGATCT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TGCTCACGACGTCGCCGCCATAGCTC</a:t>
            </a:r>
            <a:r>
              <a:rPr lang="en-US" sz="10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TGGCAGATCT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1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TGCTCACGACGTCGCCGCCATAGC</a:t>
            </a:r>
            <a:r>
              <a:rPr lang="en-US" sz="1000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CC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CAGATCT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TGCTCACGACGTC</a:t>
            </a:r>
            <a:r>
              <a:rPr lang="en-US" sz="10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-------------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AGATCT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0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TGCTCACGACGTC</a:t>
            </a:r>
            <a:r>
              <a:rPr lang="en-US" sz="10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CATAGCTC-CCGT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AGATCT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1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CGGCTACGAATCCCGGAATCAACCTGTGCCAAGGAAATCCAAA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-------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GTTG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8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CGGCTACGAATCCCGGAATCAACCTGTGCCAAGGAAATCCAAA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-----------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GTTG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84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CGGCTACGAATCCCGGAATCAACCTGTGCCAAGGAAATCCAAA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CGGCTGA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GTTG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0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CGGCTACGAATCCCGGAATCAACCTGTGCCAAGGAAATCCAAA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CGGCTGA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GTTG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8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CGGCTACGAATCCCGGAATCAACCTGTGCCAAGGAAATCCAAA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CGGCTGA</a:t>
            </a:r>
            <a:r>
              <a:rPr lang="en-US" sz="1000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CGCGTTG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9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TTTCAAGATGAGATGTGTCATATGACGACGGATGCTCATGGTCTTGACATGGAGGAGACCTTGGTGGAGGCTAT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6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TTTCAAGATGAGATGTGTCATATGACGACGGATGCTCATGGTCTTGACATGGAGGAGACCTTGGTGGAGGCTAT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64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TTTCAAGATGAGATGTGTCATATGACGACGGATGCTCATGGTCTTGACATGGAGGAGACCTTGGTGGAGGCTAT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8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TTTCAAGATGAGATGTGTCATATGACGACGGATGCTCATGGTCTTGACATGGAGGAGACCTTGGTGGAGGCTAT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6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TTTCAAGATGAGATGTGTCATATGACGACGGATGCTCATGGTCTTGACATGGAGGAGACCTTGGTGGAGGCTAT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7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GCCGGAACAGAGCCAAGATGCGTTTTATATGGATGAAGAGGCGATGTTGGGGATGTCTAGTTTGTTGGATAACA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4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GCCGGAACAGAGCCAAGATGCGTTTTATATGGATGAAGAGGCGATGTTGGGGATGTCTAGTTTGTTGGATAACA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44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GCCGGAACAGAGCCAAGATGCGTTTTATATGGATGAAGAGGCGATGTTGGGGATGTCTAGTTTGTTGGATAACA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GCCGGAACAGAGCCAAGATGCGTTTTATATGGATGAAGAGGCGATGTTGGGGATGTCTAGTTTGTTGGATAACA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4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CGCCGGAACAGAGCCAAGATGCGTTTTATATGGATGAAGAGGCGATGTTGGGGATGTCTAGTTTGTTGGATAACATG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5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AAGGGATGCTTTTACCGTCGCCGTCGGTTCAATGGAACTATAATTTTGATGTCGAGGGAGATGATGACGTGTCC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27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AAGGGATGCTTTTACCGTCGCCGTCGGTTCAATGGAACTATAATTTTGATGTCGAGGGAGATGATGACGTGTCC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24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AAGGGATGCTTTTACCGTCGCCGTCGGTTCAATGGAACTATAATTTTGATGTCGAGGGAGATGATGACGTGTCC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AAGGGATGCTTTTACCGTCGCCGTCGGTTCAATGGAACTATAATTTTGATGTCGAGGGAGATGATGACGTGTCC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2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AAGGGATGCTTTTACCGTCGCCGTCGGTTCAATGGAACTATAATTTTGATGTCGAGGGAGATGATGACGTGTCCTTA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AGC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8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AGC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5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AGC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2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AGC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AGC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1C2F2F-2980-FD47-818A-474B1CF85C27}"/>
              </a:ext>
            </a:extLst>
          </p:cNvPr>
          <p:cNvSpPr txBox="1"/>
          <p:nvPr/>
        </p:nvSpPr>
        <p:spPr>
          <a:xfrm>
            <a:off x="224132" y="544507"/>
            <a:ext cx="359642" cy="379876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76981" y="132735"/>
            <a:ext cx="929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</a:p>
        </p:txBody>
      </p:sp>
    </p:spTree>
    <p:extLst>
      <p:ext uri="{BB962C8B-B14F-4D97-AF65-F5344CB8AC3E}">
        <p14:creationId xmlns:p14="http://schemas.microsoft.com/office/powerpoint/2010/main" val="10286626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-3755" y="1113744"/>
            <a:ext cx="7668768" cy="7089405"/>
          </a:xfrm>
          <a:prstGeom prst="rect">
            <a:avLst/>
          </a:prstGeom>
          <a:ln>
            <a:noFill/>
          </a:ln>
        </p:spPr>
        <p:txBody>
          <a:bodyPr wrap="square" lIns="101882" tIns="50941" rIns="101882" bIns="50941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TCATTTTCTG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ATGTTTGGCT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ACGAGTCTTCGGTTTCCTCAGGCGGTGATTATAT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TCATTTTCTG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ATGTTTGGCT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ACGAGTCTTCGGTTTCCTCAGGCGGTGATTATAT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TCATTTTCTG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ATGTTTGGCT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ACGAGTCTTCGGTTTCCTCAGGCGGTGATTATAT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T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TCATTTTCTG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CTGAAATGTTTGGCTC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</a:t>
            </a:r>
            <a:r>
              <a:rPr lang="en-US" sz="1000" b="1" dirty="0">
                <a:solidFill>
                  <a:srgbClr val="FF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ACGAGTCTTCGGTTTCCTCAGGCGGTGATTATATTC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80 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CGCTTGCGAGCAGCTGCCCCAAGAAACCGGCGGGTCGTAAGAAGTTTCGTGAGACTCGTCACCCAATA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CGCTTGCGAGCAGCTGCCCCAAGAAACCGGCGGGTCGTAAGAAGTTTCGTGAGACTCGTCACCCAATA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CGCTTGCGAGCAGCTGCCCCAAGAAACCGGCGGGTCGTAAGAAGTTTCGTGAGACTCGTCACCCAATA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ACGCTTGCGAGCAGCTGCCCCAAGAAACCGGCGGGTCGTAAGAAGTTTCGTGAGACTCGTCACCCAATATACAGAGG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1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GGAGAAACTCCGGTAAGTGGGTTTGTGAGGTTAGAGAACCAAACAAGAAAACAAGGATTTGGCTCGGAACATT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GGAGAAACTCCGGTAAGTGGGTTTGTGAGGTTAGAGAACCAAACAAGAAAACAAGGATTTGGCTCGGAACATT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GGAGAAACTCCGGTAAGTGGGTTTGTGAGGTTAGAGAACCAAACAAGAAAACAAGGATTTGGCTCGGAACATT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TCGTCGGAGAAACTCCGGTAAGTGGGTTTGTGAGGTTAGAGAACCAAACAAGAAAACAAGGATTTGGCTCGGAACATTT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2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AGCTCACGACGTTGCCGCTTTAGCCCTTCGTGGCCGATCA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AGCTCACGACGTTGCCGCTTTAGCCCTTCGTGGCCGATCA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AGCTCACGACGTTGCCGCTTTAGCCCTTCGTGGCCGATCA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AAACCGCTGAGATGGCAGCTCGAGCTCACGACGTTGCCGCTTTAGCCCTTCGTGGCCGATCAGCCTGTCTCAATTTCG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2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AGACTCCGAATCCCGGAATCAACTTGCGCTAAGGACATCCAAAAGGCGGCGGCTGAAGCTG</a:t>
            </a:r>
            <a:r>
              <a:rPr lang="en-US" sz="1100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T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9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AGACTCCGAATCCCGGAATCAACTTGCGCTAAGGACATCCAAAAGGCGGCGGCTGAAGCTG</a:t>
            </a:r>
            <a:r>
              <a:rPr lang="en-US" sz="11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T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0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AGACTCCGAATCCCGGAATCAACTTGCGCTAAGGACATCCAAAAGGCGGCGGCTGAAGCTG</a:t>
            </a:r>
            <a:r>
              <a:rPr lang="en-US" sz="1100" b="1" dirty="0"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-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T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39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ACTCGGCTTGGAGACTCCGAATCCCGGAATCAACTTGCGCTAAGGACATCCAAAAGGCGGCGGCTGAAGCTG</a:t>
            </a:r>
            <a:r>
              <a:rPr lang="en-US" sz="1100" b="1" dirty="0">
                <a:solidFill>
                  <a:srgbClr val="0070C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CGTT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0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GTTTCAGGATGAGATGTGTGATGCGACGACGGATCATGGCTTCGACATGGAGGAGACGTTGGTGGAGGCTATTTACA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7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GTTTCAGGATGAGATGTGTGATGCGACGACGGATCATGGCTTCGACATGGAGGAGACGTTGGTGGAGGCTATTTACA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8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GTTTCAGGATGAGATGTGTGATGCGACGACGGATCATGGCTTCGACATGGAGGAGACGTTGGTGGAGGCTATTTACA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7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CGTTTCAGGATGAGATGTGTGATGCGACGACGGATCATGGCTTCGACATGGAGGAGACGTTGGTGGAGGCTATTTACAC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48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AACAGAGCGAAAATGCGTTTTATATGCACGATGAGGCGATGTTTGAGATGCCGAGTTTGTTGGCTAATATGGC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5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AACAGAGCGAAAATGCGTTTTATATGCACGATGAGGCGATGTTTGAGATGCCGAGTTTGTTGGCTAATATGGC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AACAGAGCGAAAATGCGTTTTATATGCACGATGAGGCGATGTTTGAGATGCCGAGTTTGTTGGCTAATATGGC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5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GGCGGAACAGAGCGAAAATGCGTTTTATATGCACGATGAGGCGATGTTTGAGATGCCGAGTTTGTTGGCTAATATGGCAG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56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GGGATGCTTTTGCCGCTTCCGTCCGTACAGTGGAATCATAATCATGAAGTCGACGGCGATGATGACGACGTATCGTT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GGGATGCTTTTGCCGCTTCCGTCCGTACAGTGGAATCATAATCATGAAGTCGACGGCGATGATGACGACGTATCGTT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GGGATGCTTTTGCCGCTTCCGTCCGTACAGTGGAATCATAATCATGAAGTCGACGGCGATGATGACGACGTATCGTT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39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AAGGGATGCTTTTGCCGCTTCCGTCCGTACAGTGGAATCATAATCATGAAGTCGACGGCGATGATGACGACGTATCGTT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40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GT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it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GT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       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GT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1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sw:cbf123  </a:t>
            </a:r>
            <a:r>
              <a:rPr lang="en-US" sz="1000" dirty="0">
                <a:solidFill>
                  <a:srgbClr val="000000"/>
                </a:solidFill>
                <a:highlight>
                  <a:srgbClr val="FFFFFF"/>
                </a:highlight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TGGAGTTATTAA</a:t>
            </a:r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 652 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  <a:p>
            <a:r>
              <a:rPr 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Malgun Gothic"/>
                <a:cs typeface="Courier New" panose="02070309020205020404" pitchFamily="49" charset="0"/>
              </a:rPr>
              <a:t> </a:t>
            </a:r>
            <a:endParaRPr lang="en-US" sz="1000" dirty="0">
              <a:latin typeface="Courier New" panose="02070309020205020404" pitchFamily="49" charset="0"/>
              <a:ea typeface="Malgun Gothic"/>
              <a:cs typeface="Courier New" panose="02070309020205020404" pitchFamily="49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41C2F2F-2980-FD47-818A-474B1CF85C27}"/>
              </a:ext>
            </a:extLst>
          </p:cNvPr>
          <p:cNvSpPr txBox="1"/>
          <p:nvPr/>
        </p:nvSpPr>
        <p:spPr>
          <a:xfrm>
            <a:off x="224133" y="584262"/>
            <a:ext cx="372466" cy="379876"/>
          </a:xfrm>
          <a:prstGeom prst="rect">
            <a:avLst/>
          </a:prstGeom>
          <a:noFill/>
        </p:spPr>
        <p:txBody>
          <a:bodyPr wrap="none" lIns="101882" tIns="50941" rIns="101882" bIns="50941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6981" y="132735"/>
            <a:ext cx="929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</a:p>
        </p:txBody>
      </p:sp>
    </p:spTree>
    <p:extLst>
      <p:ext uri="{BB962C8B-B14F-4D97-AF65-F5344CB8AC3E}">
        <p14:creationId xmlns:p14="http://schemas.microsoft.com/office/powerpoint/2010/main" val="217384030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/>
          <p:cNvGrpSpPr/>
          <p:nvPr/>
        </p:nvGrpSpPr>
        <p:grpSpPr>
          <a:xfrm>
            <a:off x="141957" y="6949816"/>
            <a:ext cx="7547809" cy="2848747"/>
            <a:chOff x="76200" y="6800868"/>
            <a:chExt cx="7547809" cy="2848747"/>
          </a:xfrm>
        </p:grpSpPr>
        <p:cxnSp>
          <p:nvCxnSpPr>
            <p:cNvPr id="23" name="Straight Connector 22"/>
            <p:cNvCxnSpPr/>
            <p:nvPr/>
          </p:nvCxnSpPr>
          <p:spPr>
            <a:xfrm>
              <a:off x="4681503" y="7106442"/>
              <a:ext cx="2395340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cxnSp>
          <p:nvCxnSpPr>
            <p:cNvPr id="24" name="Straight Connector 23"/>
            <p:cNvCxnSpPr/>
            <p:nvPr/>
          </p:nvCxnSpPr>
          <p:spPr>
            <a:xfrm>
              <a:off x="1155700" y="8882942"/>
              <a:ext cx="4076488" cy="0"/>
            </a:xfrm>
            <a:prstGeom prst="line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</a:ln>
            <a:effectLst/>
          </p:spPr>
        </p:cxnSp>
        <p:cxnSp>
          <p:nvCxnSpPr>
            <p:cNvPr id="25" name="Straight Connector 24"/>
            <p:cNvCxnSpPr/>
            <p:nvPr/>
          </p:nvCxnSpPr>
          <p:spPr>
            <a:xfrm>
              <a:off x="1053551" y="8003467"/>
              <a:ext cx="2070649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sp>
          <p:nvSpPr>
            <p:cNvPr id="30" name="TextBox 29"/>
            <p:cNvSpPr txBox="1"/>
            <p:nvPr/>
          </p:nvSpPr>
          <p:spPr>
            <a:xfrm>
              <a:off x="149972" y="6800868"/>
              <a:ext cx="2792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76200" y="7079681"/>
              <a:ext cx="7547809" cy="256993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M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S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FSAFSEMFGSDYESSVSSGGDYIPTLASSCPKKPAGRKKFRETRHPIYRGVRRRNSGKWVCEV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M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S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FSAFSEMFGSDYESSVSSGGDYIPTLASSCPKKPAGRKKFRETRHPIYRGVRRRNSGKWVCEV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M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N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FSAFSEMFGSDYESSVSSGGDYIPTLASSCPKKPAGRKKFRETRHPIYRGVRRRNSGKWVCEV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M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N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FSAFSEMFGSDYESSVSSGGDYIPTLASSCPKKPAGRKKFRETRHPIYRGVRRRNSGKWVCEV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QTAEMAARAHDVAALALRGRSACLNFADSAWRLRIPESTCAKDIQKAAAEAALAFQDEMCDATTDHGFDMEETLVEAIYT 160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QTAEMAARAHDVAALALRGRSACLNFADSAWRLRIPESTCAKDIQKAAAE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GVGVSG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3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QTAEMAARAHDVAALALRGRSACLNFADSAWRLRIPESTCAKDIQKAAAEAALAFQDEMCDATTDHGFDMEETLVEAIYT 160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QTAEMAARAHDVAALALRGRSACLNFADSAWRLRIPESTCAKDIQKAAAE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VVGVSG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3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AEQSENAFYMHDEAMFEMPSLLANMAEGMLLPLPSVQWNHNHEVDGDDDDVSLWSY 216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3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AEQSENAFYMHDEAMFEMPSLLANMAEGMLLPLPSVQWNHNHEVDGDDDDVSLWSY 216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3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85939" y="358401"/>
            <a:ext cx="7585773" cy="2874808"/>
            <a:chOff x="85939" y="126177"/>
            <a:chExt cx="7585773" cy="2874808"/>
          </a:xfrm>
        </p:grpSpPr>
        <p:sp>
          <p:nvSpPr>
            <p:cNvPr id="26" name="Rectangle 25"/>
            <p:cNvSpPr/>
            <p:nvPr/>
          </p:nvSpPr>
          <p:spPr>
            <a:xfrm>
              <a:off x="100688" y="436822"/>
              <a:ext cx="7571024" cy="25641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MNSFSAFSEMFGSDYEPQGGDYCPTLATSCPKKPAGRKKFRETRHPIYRGVRQRNSGKWVSEVREPNKKTRIWLGTFQTA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MNSFSAFSEMFGSDYEPQGGDYCPTLATSCPKKPAGRKKFRETRHPIYRGVRQRNSGKWVSEVREPNKKTRIWLGTFQTA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MNSFSAFSEMFGSDYEPQGGDYCPTLATSCPKKPAGRKKFRETRHPIYRGVRQRNSGKWVSEVREPNKKTRIWLGTFQTA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MNSFSAFSEMFGSDYEPQGGDYCPTLATSCPKKPAGRKKFRETRHPIYRGVRQRNSGKWVSEVREPNKKTRIWLGTFQTA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EMAARAHDVAALALRGRSACLNFADSAWRLRIPESTCAKDIQKAAAEAALAFQDETCDTTTTDHGLDMEETMVEAIYTPE 160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EMAARAHDVAAL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CLNFADSAWRLRIPESTCAKDIQKAAAEAALAFQDETCDTTTTDHGLDMEETMVEAIYTPE 154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EMAARAHDVAALALRGRSACLNFADSAWRLRIPESTCAKDIQKAAAEAALAFQDETCDTTTTDHGLDMEETMVEAIYTPE 160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EMAARAHDVA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FPWPISMSQLR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-- 102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QSEGAFYMDEETMFGMP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S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LLDNMAEGMLLPPPSVQWNHNYDGEGDGDVSLWSY 213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QSEGAFYMDEETMFGMP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S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LLDNMAEGMLLPPPSVQWNHNYDGEGDGDVSLWSY 20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QSEGAFYMDEETMFGMP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T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LLDNMAEGMLLPPPSVQWNHNYDGEGDGDVSLWSY 213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----------------------------------------------------- 102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</p:txBody>
        </p:sp>
        <p:cxnSp>
          <p:nvCxnSpPr>
            <p:cNvPr id="17" name="Straight Connector 16"/>
            <p:cNvCxnSpPr/>
            <p:nvPr/>
          </p:nvCxnSpPr>
          <p:spPr>
            <a:xfrm>
              <a:off x="4454276" y="509926"/>
              <a:ext cx="2625504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cxnSp>
          <p:nvCxnSpPr>
            <p:cNvPr id="18" name="Straight Connector 17"/>
            <p:cNvCxnSpPr/>
            <p:nvPr/>
          </p:nvCxnSpPr>
          <p:spPr>
            <a:xfrm>
              <a:off x="1033902" y="2230776"/>
              <a:ext cx="4002664" cy="0"/>
            </a:xfrm>
            <a:prstGeom prst="line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</a:ln>
            <a:effectLst/>
          </p:spPr>
        </p:cxnSp>
        <p:cxnSp>
          <p:nvCxnSpPr>
            <p:cNvPr id="19" name="Straight Connector 18"/>
            <p:cNvCxnSpPr/>
            <p:nvPr/>
          </p:nvCxnSpPr>
          <p:spPr>
            <a:xfrm>
              <a:off x="1044789" y="1373526"/>
              <a:ext cx="1797471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sp>
          <p:nvSpPr>
            <p:cNvPr id="28" name="TextBox 27"/>
            <p:cNvSpPr txBox="1"/>
            <p:nvPr/>
          </p:nvSpPr>
          <p:spPr>
            <a:xfrm>
              <a:off x="85939" y="12617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  <p:grpSp>
        <p:nvGrpSpPr>
          <p:cNvPr id="46" name="Group 45"/>
          <p:cNvGrpSpPr/>
          <p:nvPr/>
        </p:nvGrpSpPr>
        <p:grpSpPr>
          <a:xfrm>
            <a:off x="101145" y="3451629"/>
            <a:ext cx="7551680" cy="3415223"/>
            <a:chOff x="28575" y="2856555"/>
            <a:chExt cx="7743826" cy="3415223"/>
          </a:xfrm>
        </p:grpSpPr>
        <p:sp>
          <p:nvSpPr>
            <p:cNvPr id="27" name="Rectangle 26"/>
            <p:cNvSpPr/>
            <p:nvPr/>
          </p:nvSpPr>
          <p:spPr>
            <a:xfrm>
              <a:off x="28575" y="3170929"/>
              <a:ext cx="7743826" cy="310084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MNS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F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AFSEMFGSDYESPVSSGGDYSPKLATSCPKKPAGRKKFRETRHPIYRGVRQRNSGKWVCEL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MNS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F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AFSEMFGSDYESPVSSGGDYSPKLATSCPKKPAGRKKFRETRHPIYRGVRQRNSGKWVCEL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MNS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C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AFSEMFGSDYESPVSSGGDYSPKLATSCPKKPAGRKKFRETRHPIYRGVRQRNSGKWVCEL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2    MNS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C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AFSEMFGSDYESPVSSGGDYSPKLATSCPKKPAGRKKFRETRHPIYRGVRQRNSGKWVCEL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MNS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C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AFSEMFGSDYESPVSSGGDYSPKLATSCPKKPAGRKKFRETRHPIYRGVRQRNSGKWVCELREPNKKTRIWLGTF 80 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QTAEMAARAHDVAAI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L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RGRSACLNFADSAWRLRIPESTCAKEIQKPR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-------------------------------- 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128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QTAEMAARAHDVAAI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RGRSACLNFADSAWRLRIPESTCAKEIQKPR</a:t>
              </a:r>
              <a:r>
                <a:rPr lang="en-US" sz="1000" b="1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-------------------------------- 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12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QTAEMAARAHDVAAI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L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RGRSACLNFADSAWRLRIPESTCAKEIQKAAAEAALNFQDEMCHMTTDAHGLDMEETLVEAIY 160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2    QTAEMAARAHDV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DLPVSISLTRLGGYESRNQPVPRKSKRRRLKPR---------------------------- 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126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QTAEMAARAHDVAAIA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PVADLPVSISLTRLGGYESRNQPVPRKSKRRRLKPR---------------------------- 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132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 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         </a:t>
              </a:r>
              <a:r>
                <a:rPr lang="en-US" sz="1000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28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it:cbf123  </a:t>
              </a:r>
              <a:r>
                <a:rPr lang="en-US" sz="1000" dirty="0">
                  <a:solidFill>
                    <a:srgbClr val="FF000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27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         TPEQSQDAFYMDEEAMLGMSSLLDNMAEGMLLPSPSVQWNYNFDVEGDDDVSLWSY 216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2    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26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  <a:p>
              <a:pPr>
                <a:lnSpc>
                  <a:spcPct val="115000"/>
                </a:lnSpc>
              </a:pP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sw:cbf123  </a:t>
              </a:r>
              <a:r>
                <a:rPr lang="en-US" sz="1000" b="1" dirty="0">
                  <a:solidFill>
                    <a:srgbClr val="0070C0"/>
                  </a:solidFill>
                  <a:latin typeface="Courier New"/>
                  <a:ea typeface="Malgun Gothic"/>
                  <a:cs typeface="Times New Roman"/>
                </a:rPr>
                <a:t>--------------------------------------------------------</a:t>
              </a:r>
              <a:r>
                <a:rPr lang="en-US" sz="1000" dirty="0">
                  <a:solidFill>
                    <a:srgbClr val="000000"/>
                  </a:solidFill>
                  <a:latin typeface="Courier New"/>
                  <a:ea typeface="Malgun Gothic"/>
                  <a:cs typeface="Times New Roman"/>
                </a:rPr>
                <a:t> 132 </a:t>
              </a:r>
              <a:endParaRPr lang="en-US" sz="1000" dirty="0">
                <a:solidFill>
                  <a:prstClr val="black"/>
                </a:solidFill>
                <a:ea typeface="Malgun Gothic"/>
                <a:cs typeface="Times New Roman"/>
              </a:endParaRPr>
            </a:p>
          </p:txBody>
        </p:sp>
        <p:cxnSp>
          <p:nvCxnSpPr>
            <p:cNvPr id="20" name="Straight Connector 19"/>
            <p:cNvCxnSpPr/>
            <p:nvPr/>
          </p:nvCxnSpPr>
          <p:spPr>
            <a:xfrm>
              <a:off x="4705350" y="3226477"/>
              <a:ext cx="2541116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cxnSp>
          <p:nvCxnSpPr>
            <p:cNvPr id="21" name="Straight Connector 20"/>
            <p:cNvCxnSpPr/>
            <p:nvPr/>
          </p:nvCxnSpPr>
          <p:spPr>
            <a:xfrm>
              <a:off x="1232277" y="5367676"/>
              <a:ext cx="4076346" cy="0"/>
            </a:xfrm>
            <a:prstGeom prst="line">
              <a:avLst/>
            </a:prstGeom>
            <a:noFill/>
            <a:ln w="19050" cap="flat" cmpd="sng" algn="ctr">
              <a:solidFill>
                <a:srgbClr val="0070C0"/>
              </a:solidFill>
              <a:prstDash val="solid"/>
            </a:ln>
            <a:effectLst/>
          </p:spPr>
        </p:cxnSp>
        <p:cxnSp>
          <p:nvCxnSpPr>
            <p:cNvPr id="22" name="Straight Connector 21"/>
            <p:cNvCxnSpPr/>
            <p:nvPr/>
          </p:nvCxnSpPr>
          <p:spPr>
            <a:xfrm>
              <a:off x="986203" y="4272301"/>
              <a:ext cx="2090372" cy="0"/>
            </a:xfrm>
            <a:prstGeom prst="line">
              <a:avLst/>
            </a:prstGeom>
            <a:noFill/>
            <a:ln w="19050" cap="flat" cmpd="sng" algn="ctr">
              <a:solidFill>
                <a:srgbClr val="FF0000"/>
              </a:solidFill>
              <a:prstDash val="solid"/>
            </a:ln>
            <a:effectLst/>
          </p:spPr>
        </p:cxnSp>
        <p:sp>
          <p:nvSpPr>
            <p:cNvPr id="29" name="TextBox 28"/>
            <p:cNvSpPr txBox="1"/>
            <p:nvPr/>
          </p:nvSpPr>
          <p:spPr>
            <a:xfrm>
              <a:off x="76200" y="2856555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176981" y="132735"/>
            <a:ext cx="929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1 Fig</a:t>
            </a:r>
          </a:p>
        </p:txBody>
      </p:sp>
    </p:spTree>
    <p:extLst>
      <p:ext uri="{BB962C8B-B14F-4D97-AF65-F5344CB8AC3E}">
        <p14:creationId xmlns:p14="http://schemas.microsoft.com/office/powerpoint/2010/main" val="36067358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9373" y="1834715"/>
            <a:ext cx="6777461" cy="1210873"/>
          </a:xfrm>
          <a:prstGeom prst="rect">
            <a:avLst/>
          </a:prstGeom>
          <a:noFill/>
        </p:spPr>
        <p:txBody>
          <a:bodyPr wrap="square" lIns="101882" tIns="50941" rIns="101882" bIns="50941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Fig. Alignment of nucleotide and amino acid sequences for the CBF coding regions in SW, IT and CRISPR mutant plan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ucleotide sequences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A)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) an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C) and amino acid sequences for CBF1 (D), CBF2 (E) and CBF3 (F) in IT, it:c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f12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SW, sw: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w: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f12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.  Differences between IT and SW sequences are indicated in red; CRISPR-induced mutations are indicated in blue.  In protein sequences, red and blue lines indicate the AP2 DNA-Binding Domain and Activation Domain, respectively.</a:t>
            </a:r>
          </a:p>
        </p:txBody>
      </p:sp>
    </p:spTree>
    <p:extLst>
      <p:ext uri="{BB962C8B-B14F-4D97-AF65-F5344CB8AC3E}">
        <p14:creationId xmlns:p14="http://schemas.microsoft.com/office/powerpoint/2010/main" val="3243883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29</TotalTime>
  <Words>233</Words>
  <Application>Microsoft Macintosh PowerPoint</Application>
  <PresentationFormat>Custom</PresentationFormat>
  <Paragraphs>19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Malgun Gothic</vt:lpstr>
      <vt:lpstr>Arial</vt:lpstr>
      <vt:lpstr>Calibri</vt:lpstr>
      <vt:lpstr>Courier New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lmour, Sarah</dc:creator>
  <cp:lastModifiedBy>Thomashow, Michael</cp:lastModifiedBy>
  <cp:revision>14</cp:revision>
  <cp:lastPrinted>2018-10-09T13:46:03Z</cp:lastPrinted>
  <dcterms:created xsi:type="dcterms:W3CDTF">2018-07-27T15:06:50Z</dcterms:created>
  <dcterms:modified xsi:type="dcterms:W3CDTF">2018-11-09T14:22:58Z</dcterms:modified>
</cp:coreProperties>
</file>